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>
      <p:cViewPr>
        <p:scale>
          <a:sx n="200" d="100"/>
          <a:sy n="200" d="100"/>
        </p:scale>
        <p:origin x="-90" y="-27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0927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3273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0021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2377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450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117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0569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5413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5767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7187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2479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EE457F-161B-4076-A5E2-C6AEEB4E6522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72111-9AF7-49F0-A796-02A2050F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4438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920CE43-C970-6357-A575-11DBE48F55BC}"/>
              </a:ext>
            </a:extLst>
          </p:cNvPr>
          <p:cNvSpPr txBox="1"/>
          <p:nvPr/>
        </p:nvSpPr>
        <p:spPr>
          <a:xfrm>
            <a:off x="1269218" y="4237892"/>
            <a:ext cx="647993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 plot showing a 500-kb QTN region LD pattern among the 61 SNPs genotyped. The LD between the SNPs is measured as R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hown (× 100) in the diamond at the intersection of the diagonals from each SNP.  R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 is shown as white, 0 &lt; R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1 in orange and R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 in red. The dots at the top shows the SNPs according to chromosomal location. The dashed line indicated  significant value. (A) LD plot was constructed by a 500-kb region of the QTN that is a common with all six single locus models.  The blue dot above the red dashed line is a significant associated SNP at chromosomal DNA sequence position at 175,187,718 bp with Rg1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ent. (B) LD plot was constructed by a 500-kb region of the QTN that is a common with all five multiple locus models. The red dot above the blue dashed line is a significant associated SNP at chromosomal DNA sequence position at 329,713,841 bp with Rg1 content. 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4F981876-4E06-5424-5ADD-F1D1D15833FD}"/>
              </a:ext>
            </a:extLst>
          </p:cNvPr>
          <p:cNvGrpSpPr/>
          <p:nvPr/>
        </p:nvGrpSpPr>
        <p:grpSpPr>
          <a:xfrm>
            <a:off x="1285068" y="640168"/>
            <a:ext cx="3225386" cy="3342747"/>
            <a:chOff x="1285068" y="640168"/>
            <a:chExt cx="3225386" cy="3342747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F8148232-C378-328C-E4B3-12EBE4135BDF}"/>
                </a:ext>
              </a:extLst>
            </p:cNvPr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1285068" y="719298"/>
              <a:ext cx="3225386" cy="3263617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157D2B57-8190-BE4A-ED29-6C49ABB43976}"/>
                </a:ext>
              </a:extLst>
            </p:cNvPr>
            <p:cNvSpPr txBox="1"/>
            <p:nvPr/>
          </p:nvSpPr>
          <p:spPr>
            <a:xfrm>
              <a:off x="1619250" y="640168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A</a:t>
              </a:r>
              <a:endParaRPr lang="zh-CN" altLang="en-US" dirty="0"/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AD223E6F-CAEF-A0DD-7E5F-7E95323FF14E}"/>
              </a:ext>
            </a:extLst>
          </p:cNvPr>
          <p:cNvGrpSpPr/>
          <p:nvPr/>
        </p:nvGrpSpPr>
        <p:grpSpPr>
          <a:xfrm>
            <a:off x="4321225" y="694139"/>
            <a:ext cx="3041600" cy="3288776"/>
            <a:chOff x="4321225" y="694139"/>
            <a:chExt cx="3041600" cy="3288776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2D1A35C-C775-53C1-1C00-42C64BCAEAE6}"/>
                </a:ext>
              </a:extLst>
            </p:cNvPr>
            <p:cNvPicPr/>
            <p:nvPr/>
          </p:nvPicPr>
          <p:blipFill>
            <a:blip r:embed="rId3"/>
            <a:stretch>
              <a:fillRect/>
            </a:stretch>
          </p:blipFill>
          <p:spPr>
            <a:xfrm>
              <a:off x="4321225" y="1120593"/>
              <a:ext cx="3041600" cy="2862322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271D82A4-C751-8C89-1BE1-95D11E73A219}"/>
                </a:ext>
              </a:extLst>
            </p:cNvPr>
            <p:cNvSpPr txBox="1"/>
            <p:nvPr/>
          </p:nvSpPr>
          <p:spPr>
            <a:xfrm>
              <a:off x="4553759" y="694139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B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560056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8</TotalTime>
  <Words>188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P Zhang</dc:creator>
  <cp:lastModifiedBy>MDPI</cp:lastModifiedBy>
  <cp:revision>4</cp:revision>
  <dcterms:created xsi:type="dcterms:W3CDTF">2024-03-31T06:39:33Z</dcterms:created>
  <dcterms:modified xsi:type="dcterms:W3CDTF">2024-07-10T09:23:25Z</dcterms:modified>
</cp:coreProperties>
</file>